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096" autoAdjust="0"/>
    <p:restoredTop sz="95130" autoAdjust="0"/>
  </p:normalViewPr>
  <p:slideViewPr>
    <p:cSldViewPr snapToGrid="0" snapToObjects="1">
      <p:cViewPr varScale="1">
        <p:scale>
          <a:sx n="114" d="100"/>
          <a:sy n="114" d="100"/>
        </p:scale>
        <p:origin x="-4008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817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62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952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000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440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078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347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837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684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44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58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F9CDD-8E66-884E-9EED-6ECC253D9D43}" type="datetimeFigureOut">
              <a:rPr lang="en-US" smtClean="0"/>
              <a:t>6/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AAF57-5401-F84C-8406-79B60F414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114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7" descr="Normal MRI.pct                                                 000A4B46Macintosh HD                   BC2CBEB4: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6" t="9885" r="22621" b="20116"/>
          <a:stretch>
            <a:fillRect/>
          </a:stretch>
        </p:blipFill>
        <p:spPr bwMode="auto">
          <a:xfrm>
            <a:off x="347662" y="719854"/>
            <a:ext cx="6177243" cy="54038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10156" y="6698855"/>
            <a:ext cx="564394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: MR T1 weighted midline sagittal </a:t>
            </a:r>
          </a:p>
          <a:p>
            <a:r>
              <a:rPr lang="en-US" dirty="0" smtClean="0"/>
              <a:t>Image illustrating normal cerebellar volume occupying the</a:t>
            </a:r>
          </a:p>
          <a:p>
            <a:r>
              <a:rPr lang="en-US" dirty="0" smtClean="0"/>
              <a:t>posterior fossa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8376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</TotalTime>
  <Words>18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>Waters' Edge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hael waters</dc:creator>
  <cp:keywords/>
  <dc:description/>
  <cp:lastModifiedBy>michael waters</cp:lastModifiedBy>
  <cp:revision>3</cp:revision>
  <dcterms:created xsi:type="dcterms:W3CDTF">2013-06-06T13:23:18Z</dcterms:created>
  <dcterms:modified xsi:type="dcterms:W3CDTF">2013-06-07T15:41:48Z</dcterms:modified>
  <cp:category/>
</cp:coreProperties>
</file>